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4" d="100"/>
          <a:sy n="84" d="100"/>
        </p:scale>
        <p:origin x="28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F59184-9C9A-4352-81BB-E3640D7407D6}" type="datetimeFigureOut">
              <a:rPr lang="en-GB" smtClean="0"/>
              <a:t>24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5A464-BFFC-4459-A44C-0FC59E5151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74271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F59184-9C9A-4352-81BB-E3640D7407D6}" type="datetimeFigureOut">
              <a:rPr lang="en-GB" smtClean="0"/>
              <a:t>24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5A464-BFFC-4459-A44C-0FC59E5151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87840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F59184-9C9A-4352-81BB-E3640D7407D6}" type="datetimeFigureOut">
              <a:rPr lang="en-GB" smtClean="0"/>
              <a:t>24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5A464-BFFC-4459-A44C-0FC59E5151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7313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F59184-9C9A-4352-81BB-E3640D7407D6}" type="datetimeFigureOut">
              <a:rPr lang="en-GB" smtClean="0"/>
              <a:t>24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5A464-BFFC-4459-A44C-0FC59E5151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8128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F59184-9C9A-4352-81BB-E3640D7407D6}" type="datetimeFigureOut">
              <a:rPr lang="en-GB" smtClean="0"/>
              <a:t>24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5A464-BFFC-4459-A44C-0FC59E5151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38288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F59184-9C9A-4352-81BB-E3640D7407D6}" type="datetimeFigureOut">
              <a:rPr lang="en-GB" smtClean="0"/>
              <a:t>24/1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5A464-BFFC-4459-A44C-0FC59E5151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6384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F59184-9C9A-4352-81BB-E3640D7407D6}" type="datetimeFigureOut">
              <a:rPr lang="en-GB" smtClean="0"/>
              <a:t>24/12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5A464-BFFC-4459-A44C-0FC59E5151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92529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F59184-9C9A-4352-81BB-E3640D7407D6}" type="datetimeFigureOut">
              <a:rPr lang="en-GB" smtClean="0"/>
              <a:t>24/12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5A464-BFFC-4459-A44C-0FC59E5151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24785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F59184-9C9A-4352-81BB-E3640D7407D6}" type="datetimeFigureOut">
              <a:rPr lang="en-GB" smtClean="0"/>
              <a:t>24/12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5A464-BFFC-4459-A44C-0FC59E5151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1604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F59184-9C9A-4352-81BB-E3640D7407D6}" type="datetimeFigureOut">
              <a:rPr lang="en-GB" smtClean="0"/>
              <a:t>24/1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5A464-BFFC-4459-A44C-0FC59E5151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2579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F59184-9C9A-4352-81BB-E3640D7407D6}" type="datetimeFigureOut">
              <a:rPr lang="en-GB" smtClean="0"/>
              <a:t>24/1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5A464-BFFC-4459-A44C-0FC59E5151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382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F59184-9C9A-4352-81BB-E3640D7407D6}" type="datetimeFigureOut">
              <a:rPr lang="en-GB" smtClean="0"/>
              <a:t>24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35A464-BFFC-4459-A44C-0FC59E5151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72284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00E6AA39-15A3-4937-87CB-17364CECE82B}"/>
              </a:ext>
            </a:extLst>
          </p:cNvPr>
          <p:cNvSpPr txBox="1"/>
          <p:nvPr/>
        </p:nvSpPr>
        <p:spPr>
          <a:xfrm rot="16200000">
            <a:off x="60404" y="4678316"/>
            <a:ext cx="14125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Weighted average (0-5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9A1F1C0-B2D7-4DC2-89C7-518FCC0B96AF}"/>
              </a:ext>
            </a:extLst>
          </p:cNvPr>
          <p:cNvSpPr txBox="1"/>
          <p:nvPr/>
        </p:nvSpPr>
        <p:spPr>
          <a:xfrm>
            <a:off x="2309404" y="8498985"/>
            <a:ext cx="30893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16 items relating to physical, mental and social domains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82AE78F4-9BFF-4422-80E7-5DCA6395DB03}"/>
              </a:ext>
            </a:extLst>
          </p:cNvPr>
          <p:cNvCxnSpPr/>
          <p:nvPr/>
        </p:nvCxnSpPr>
        <p:spPr>
          <a:xfrm>
            <a:off x="3246664" y="3883932"/>
            <a:ext cx="18097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1B929396-E595-4464-96D7-1DE2188F6C6D}"/>
              </a:ext>
            </a:extLst>
          </p:cNvPr>
          <p:cNvCxnSpPr/>
          <p:nvPr/>
        </p:nvCxnSpPr>
        <p:spPr>
          <a:xfrm>
            <a:off x="3568609" y="3661682"/>
            <a:ext cx="18097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522BB835-9872-42CD-8E8D-0C615047D06E}"/>
              </a:ext>
            </a:extLst>
          </p:cNvPr>
          <p:cNvCxnSpPr/>
          <p:nvPr/>
        </p:nvCxnSpPr>
        <p:spPr>
          <a:xfrm>
            <a:off x="4573814" y="3509282"/>
            <a:ext cx="18097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1B0127E8-7676-4F2A-ADA3-649FD649CB39}"/>
              </a:ext>
            </a:extLst>
          </p:cNvPr>
          <p:cNvCxnSpPr/>
          <p:nvPr/>
        </p:nvCxnSpPr>
        <p:spPr>
          <a:xfrm>
            <a:off x="6224814" y="3566432"/>
            <a:ext cx="18097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A8048201-C80C-4868-BEF0-0D043156F81A}"/>
              </a:ext>
            </a:extLst>
          </p:cNvPr>
          <p:cNvCxnSpPr/>
          <p:nvPr/>
        </p:nvCxnSpPr>
        <p:spPr>
          <a:xfrm>
            <a:off x="5888264" y="3661682"/>
            <a:ext cx="18097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18225CE3-E1A8-4EAB-B26F-C1F994B256BF}"/>
              </a:ext>
            </a:extLst>
          </p:cNvPr>
          <p:cNvCxnSpPr/>
          <p:nvPr/>
        </p:nvCxnSpPr>
        <p:spPr>
          <a:xfrm>
            <a:off x="5558064" y="3706132"/>
            <a:ext cx="18097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2B37E4A9-0D17-46AA-9E3F-EDF2368E3AF0}"/>
              </a:ext>
            </a:extLst>
          </p:cNvPr>
          <p:cNvCxnSpPr/>
          <p:nvPr/>
        </p:nvCxnSpPr>
        <p:spPr>
          <a:xfrm>
            <a:off x="5217736" y="3801382"/>
            <a:ext cx="18097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A763056D-6CA7-478F-84E2-2DAE2FA8F419}"/>
              </a:ext>
            </a:extLst>
          </p:cNvPr>
          <p:cNvCxnSpPr/>
          <p:nvPr/>
        </p:nvCxnSpPr>
        <p:spPr>
          <a:xfrm>
            <a:off x="4237264" y="3702957"/>
            <a:ext cx="18097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61ABA60B-7B68-4B7C-9860-D79E25C7D245}"/>
              </a:ext>
            </a:extLst>
          </p:cNvPr>
          <p:cNvSpPr txBox="1"/>
          <p:nvPr/>
        </p:nvSpPr>
        <p:spPr>
          <a:xfrm>
            <a:off x="3206346" y="3702957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D724064-DEF3-4E61-8067-84BE3CFA08F6}"/>
              </a:ext>
            </a:extLst>
          </p:cNvPr>
          <p:cNvSpPr txBox="1"/>
          <p:nvPr/>
        </p:nvSpPr>
        <p:spPr>
          <a:xfrm>
            <a:off x="3498769" y="348268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4C78021-B0F1-4B3C-B6D5-7D1A0D714B90}"/>
              </a:ext>
            </a:extLst>
          </p:cNvPr>
          <p:cNvSpPr txBox="1"/>
          <p:nvPr/>
        </p:nvSpPr>
        <p:spPr>
          <a:xfrm>
            <a:off x="4196946" y="352438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A4172F8-EEF7-4ABF-97A5-BCF6E61D0463}"/>
              </a:ext>
            </a:extLst>
          </p:cNvPr>
          <p:cNvSpPr txBox="1"/>
          <p:nvPr/>
        </p:nvSpPr>
        <p:spPr>
          <a:xfrm>
            <a:off x="4458497" y="3331481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57DFA9A-C2D1-4251-AFA9-67692B405AA7}"/>
              </a:ext>
            </a:extLst>
          </p:cNvPr>
          <p:cNvSpPr txBox="1"/>
          <p:nvPr/>
        </p:nvSpPr>
        <p:spPr>
          <a:xfrm>
            <a:off x="6107552" y="3370782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7712217-823D-4984-8C2A-98A9E110341B}"/>
              </a:ext>
            </a:extLst>
          </p:cNvPr>
          <p:cNvSpPr txBox="1"/>
          <p:nvPr/>
        </p:nvSpPr>
        <p:spPr>
          <a:xfrm>
            <a:off x="5102249" y="3621180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C437738-6646-43F2-B2BC-FF3D790E45A6}"/>
              </a:ext>
            </a:extLst>
          </p:cNvPr>
          <p:cNvSpPr txBox="1"/>
          <p:nvPr/>
        </p:nvSpPr>
        <p:spPr>
          <a:xfrm>
            <a:off x="5512167" y="352438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A898BB7-2F28-42D8-BC61-DFD241B7ECA0}"/>
              </a:ext>
            </a:extLst>
          </p:cNvPr>
          <p:cNvSpPr txBox="1"/>
          <p:nvPr/>
        </p:nvSpPr>
        <p:spPr>
          <a:xfrm>
            <a:off x="5854456" y="348268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3F7558E-8A32-434B-9251-BC84DA29F6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2613" y="3020205"/>
            <a:ext cx="6077712" cy="5550408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A7F59C4D-DBBF-492B-8002-6A5BBE509CC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60165" y="456986"/>
            <a:ext cx="4575048" cy="2746248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4CE13987-A7D7-40A8-AEBA-4AAE63C368F2}"/>
              </a:ext>
            </a:extLst>
          </p:cNvPr>
          <p:cNvSpPr txBox="1"/>
          <p:nvPr/>
        </p:nvSpPr>
        <p:spPr>
          <a:xfrm rot="16200000">
            <a:off x="330772" y="1773476"/>
            <a:ext cx="14125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Weighted average (0-5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CF63BB0-5C77-4D07-8339-C1358D816CE0}"/>
              </a:ext>
            </a:extLst>
          </p:cNvPr>
          <p:cNvSpPr txBox="1"/>
          <p:nvPr/>
        </p:nvSpPr>
        <p:spPr>
          <a:xfrm>
            <a:off x="2666511" y="1530323"/>
            <a:ext cx="575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4.0±0.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4447CD2-2B2C-4FEF-8D66-FC9B029CA72D}"/>
              </a:ext>
            </a:extLst>
          </p:cNvPr>
          <p:cNvSpPr txBox="1"/>
          <p:nvPr/>
        </p:nvSpPr>
        <p:spPr>
          <a:xfrm>
            <a:off x="3727849" y="1433868"/>
            <a:ext cx="575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4.3±0.4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334BE16D-2CBE-4501-A14A-910A6C167E65}"/>
              </a:ext>
            </a:extLst>
          </p:cNvPr>
          <p:cNvCxnSpPr>
            <a:cxnSpLocks/>
          </p:cNvCxnSpPr>
          <p:nvPr/>
        </p:nvCxnSpPr>
        <p:spPr>
          <a:xfrm>
            <a:off x="2901960" y="1190303"/>
            <a:ext cx="116553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838DBBE5-B208-48D9-963F-17860FE63431}"/>
              </a:ext>
            </a:extLst>
          </p:cNvPr>
          <p:cNvSpPr txBox="1"/>
          <p:nvPr/>
        </p:nvSpPr>
        <p:spPr>
          <a:xfrm>
            <a:off x="3133508" y="951317"/>
            <a:ext cx="6094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>
                <a:cs typeface="Times New Roman" panose="02020603050405020304" pitchFamily="18" charset="0"/>
              </a:rPr>
              <a:t>p</a:t>
            </a:r>
            <a:r>
              <a:rPr lang="en-GB" sz="1000" dirty="0">
                <a:cs typeface="Times New Roman" panose="02020603050405020304" pitchFamily="18" charset="0"/>
              </a:rPr>
              <a:t>=0.00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82164EF-44AA-4079-9D88-FD6B6AE9CA85}"/>
              </a:ext>
            </a:extLst>
          </p:cNvPr>
          <p:cNvSpPr txBox="1"/>
          <p:nvPr/>
        </p:nvSpPr>
        <p:spPr>
          <a:xfrm>
            <a:off x="835643" y="65426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3CDA043-0000-40AA-A589-75D09579C8A8}"/>
              </a:ext>
            </a:extLst>
          </p:cNvPr>
          <p:cNvSpPr txBox="1"/>
          <p:nvPr/>
        </p:nvSpPr>
        <p:spPr>
          <a:xfrm>
            <a:off x="583076" y="318127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37" name="TextBox 8">
            <a:extLst>
              <a:ext uri="{FF2B5EF4-FFF2-40B4-BE49-F238E27FC236}">
                <a16:creationId xmlns:a16="http://schemas.microsoft.com/office/drawing/2014/main" id="{5D918A45-20D5-4C8C-80AA-B53DE9239E17}"/>
              </a:ext>
            </a:extLst>
          </p:cNvPr>
          <p:cNvSpPr txBox="1"/>
          <p:nvPr/>
        </p:nvSpPr>
        <p:spPr>
          <a:xfrm>
            <a:off x="4909614" y="39256"/>
            <a:ext cx="18896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Supplementary S3</a:t>
            </a:r>
          </a:p>
        </p:txBody>
      </p:sp>
    </p:spTree>
    <p:extLst>
      <p:ext uri="{BB962C8B-B14F-4D97-AF65-F5344CB8AC3E}">
        <p14:creationId xmlns:p14="http://schemas.microsoft.com/office/powerpoint/2010/main" val="8877835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2</TotalTime>
  <Words>37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lin Gerard Egan</dc:creator>
  <cp:lastModifiedBy>Francesca Prignano</cp:lastModifiedBy>
  <cp:revision>26</cp:revision>
  <cp:lastPrinted>2023-10-18T08:08:01Z</cp:lastPrinted>
  <dcterms:created xsi:type="dcterms:W3CDTF">2023-10-10T13:59:52Z</dcterms:created>
  <dcterms:modified xsi:type="dcterms:W3CDTF">2023-12-23T23:42:47Z</dcterms:modified>
</cp:coreProperties>
</file>